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5229A7-0AF6-4BFB-A784-3F5519CC97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2D59FF-7F96-4085-B286-73E8A7CC92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B79FD-9AB9-4611-A929-096C865B9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28545-4B16-4BF0-A64A-E5A875986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F87A7-69D7-42F4-B23D-32668CB18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00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D4718-CF42-448C-AA18-04FDF126FD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7F17F3-7CC1-49EB-9207-0F883CEBDA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CE54BF-8728-4CFF-9A0F-AA4BCB07F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AA392A-E86B-4773-B2DF-875CFD266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2A6CD0-961D-4A94-A373-80428B775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040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256F2D-C387-4B67-9D3B-8350F0A1B0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4D9312-E791-4AE6-BF17-864DAFFD88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ACA19-4977-4E0D-9927-4B9DE1983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DF6EE7-388B-417F-8ED9-72DC18C66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6BEC02-61DD-4AE7-B580-AF18540E4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265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8C6190-3F92-4E90-89C2-39A825BC3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D2CC62-1507-4D45-9266-F9CBFC3A9F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C07B6-EBEC-443D-A0A0-D514C2F92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ADCC0C-8235-4D78-B8F0-A2D2DA9AB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45C59-7111-497F-AFC2-21250F37E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064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6F1526-ECFA-4E99-9C84-0A8172E75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85F5D7-5980-49B7-8554-0176399E5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F8772-9739-48C1-9448-9D0E3880C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CF5AA9-6F3E-4432-B199-0BBEF5474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CE46D8-8AF3-4FA8-85BB-DAD173F1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280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787349-19E0-4D5A-9820-3E15F5F2E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0BF00-1575-49CA-96C3-22093D56A6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02D00A-BA24-4A6C-AF6D-9D6353174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2BB932-3B7E-449E-96F5-B5F419193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1C4FF-F7E1-412E-8B4D-ADD767534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C5931-B6E6-4BA9-9C2F-EC7947584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36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6AA205-70F7-4AD5-8290-9D94BDC85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7A1609-BF88-4392-A9FC-0215D81E75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8454F7-E035-4854-B9CF-8AF9D79D6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2B146A-6D46-4221-AEED-97D4CA4DA5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359849-5C25-406D-9D17-BCD58B1591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E66B26-4477-45E1-B64A-8213D3DC1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79B1D0-5F5B-47E0-AAF6-60431EBC8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CEFDBD-EDEE-4120-BE53-94330F7AB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129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7BAA6-5016-457F-AC47-3FB4F980E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310468-1A82-4068-9ED9-1DBB6BEF6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36AE51-34C2-44F5-9675-7C459EBE0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489295-00D8-4361-B620-BC01E6162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346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AE62EA-8DF3-4460-864C-15A8A72BF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626AB2-F025-4912-92FB-F47D8E49A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5EA296-89A1-400C-8D20-DC49804AC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710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32B0EA-82D7-46A7-96B4-592B1A699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AB630-B61F-45B7-8314-86237FC9C3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0F56F2-48A5-43CD-B51D-FBE30AE157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312CFD-57ED-491E-8CF1-8257B530A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9A96FB-06F6-4205-9D10-279405E06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5AF77F-D245-4A3C-A6A1-AB6D036CE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347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21FB6-88AA-445E-86E2-E856045ED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4DA3F4-E8AA-44B0-BF40-7F2D2A3893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96FC4F-24C4-40B8-A8B4-80FBB7DEA2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58DF60-011A-4648-8B2A-81EFFA57E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0A25DC-10A2-425F-8717-8CF742E3F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E11E5-23B8-4BC2-9D9A-C967C9A6A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750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0C2196-B118-45B8-B3C6-29B4142AC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D026DA-931E-4999-A809-634771D65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A95720-C80A-4925-A8A5-5A87600DCB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2E839-56BA-489F-B0EC-E928827DDE2D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5A4D2-3DC2-40E9-B83F-F8DE3683E8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CECF9-C820-42BA-8045-B33C28C46D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9873E-E69E-4629-A822-10E3A346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512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Table 14">
            <a:extLst>
              <a:ext uri="{FF2B5EF4-FFF2-40B4-BE49-F238E27FC236}">
                <a16:creationId xmlns:a16="http://schemas.microsoft.com/office/drawing/2014/main" id="{42630CD3-9A20-4616-B3F4-3B45EC774EA6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1617945" y="0"/>
          <a:ext cx="8848078" cy="555764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83241">
                  <a:extLst>
                    <a:ext uri="{9D8B030D-6E8A-4147-A177-3AD203B41FA5}">
                      <a16:colId xmlns:a16="http://schemas.microsoft.com/office/drawing/2014/main" val="1005822959"/>
                    </a:ext>
                  </a:extLst>
                </a:gridCol>
                <a:gridCol w="995938">
                  <a:extLst>
                    <a:ext uri="{9D8B030D-6E8A-4147-A177-3AD203B41FA5}">
                      <a16:colId xmlns:a16="http://schemas.microsoft.com/office/drawing/2014/main" val="1090701433"/>
                    </a:ext>
                  </a:extLst>
                </a:gridCol>
                <a:gridCol w="1272899">
                  <a:extLst>
                    <a:ext uri="{9D8B030D-6E8A-4147-A177-3AD203B41FA5}">
                      <a16:colId xmlns:a16="http://schemas.microsoft.com/office/drawing/2014/main" val="180494982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923584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60492722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4069819349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10088422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74360142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76889428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51368780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770254467"/>
                    </a:ext>
                  </a:extLst>
                </a:gridCol>
              </a:tblGrid>
              <a:tr h="140793">
                <a:tc gridSpan="2"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POD4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POD18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POD35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POD56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5583971"/>
                  </a:ext>
                </a:extLst>
              </a:tr>
              <a:tr h="140793">
                <a:tc gridSpan="2">
                  <a:txBody>
                    <a:bodyPr/>
                    <a:lstStyle/>
                    <a:p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Categ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Infec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Steri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Infec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Steri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Infec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Steri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Infec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Steri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7747728"/>
                  </a:ext>
                </a:extLst>
              </a:tr>
              <a:tr h="281586">
                <a:tc rowSpan="7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Cortical Allograft</a:t>
                      </a:r>
                    </a:p>
                  </a:txBody>
                  <a:tcPr vert="vert270"/>
                </a:tc>
                <a:tc rowSpan="4">
                  <a:txBody>
                    <a:bodyPr/>
                    <a:lstStyle/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Capsule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Capsule Forma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6925868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Acute Inflamma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4863007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Bacteria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6976188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Neovascularity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030991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Bon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Acute Inflamm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6139702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Bacter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4184830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Neovascular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5731127"/>
                  </a:ext>
                </a:extLst>
              </a:tr>
              <a:tr h="281586">
                <a:tc rowSpan="7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Cancellous Allograft</a:t>
                      </a:r>
                    </a:p>
                  </a:txBody>
                  <a:tcPr vert="vert270"/>
                </a:tc>
                <a:tc rowSpan="4">
                  <a:txBody>
                    <a:bodyPr/>
                    <a:lstStyle/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Capsu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Capsule Forma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0911084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Acute Inflamma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233752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Bacteria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7224186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Neovascularity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8494311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b="0" dirty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B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Acute Inflamm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7493532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Bacter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6112537"/>
                  </a:ext>
                </a:extLst>
              </a:tr>
              <a:tr h="281586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Neovascular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7070982"/>
                  </a:ext>
                </a:extLst>
              </a:tr>
              <a:tr h="281586">
                <a:tc gridSpan="11"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Supplemental Figure 11. Quantification of histological specimens. Each general cell type was quantified for a specimen from both cortical and cancellous allograft bone, either inoculated with 1*10</a:t>
                      </a:r>
                      <a:r>
                        <a:rPr lang="en-US" sz="800" b="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800" b="0" baseline="0" dirty="0">
                          <a:latin typeface="Arial"/>
                          <a:cs typeface="Arial"/>
                        </a:rPr>
                        <a:t> CFU of </a:t>
                      </a:r>
                      <a:r>
                        <a:rPr lang="en-US" sz="800" b="0" i="1" baseline="0" dirty="0">
                          <a:latin typeface="Arial"/>
                          <a:cs typeface="Arial"/>
                        </a:rPr>
                        <a:t>S. aureus 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or sterile saline as a control. The following key was used to guide grading, which was performed by author SDN, Pathologist. All cell types were quantified under a high power field (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= 400x). Vascularity was assessed using the CD31 staining as a guide (Supplemental Figure 10). Key: Capsule formation: 0 = no capsule; 1 = 1-5 cells thick; 2 = 5-10 cells thick; 3 = &gt;10 cells thick. Acute inflammation (Capsule): 0 = no acute inflammatory cells in capsule; 1 = 1 – 3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capsule; 2 = 3 – 6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capsule; 3 = &gt;6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capsule. Bacteria (Capsule): 0 = No bacterial cells in capsule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1 = 1 – 10 bacterial cells in capsule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2 = 10 – 50 bacterial cells in capsule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3 = &gt;50 bacterial cells in capsule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. Neovascularity (Capsule): 0 = no vascularity; 1 = 1 – 2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2 = 2 – 5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3 = &gt;5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. Acute Inflammation (Bone): 0 = no acute inflammatory cells in bone; 1 = 1 – 3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bone; 2 = 3 – 6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bone; 3 = &gt;6 inflammatory cell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 in capsule. Bacteria (Bone): 0 = no bacteria cells in bone; 1 = bacteria cells evident in bone. Neovascularity (Bone): 0 = no vascularity; 1 = 1 – 2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2 = 2 – 5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; 3 = &gt;5 vascular formations/</a:t>
                      </a:r>
                      <a:r>
                        <a:rPr lang="en-US" sz="800" b="0" i="0" baseline="0" dirty="0" err="1">
                          <a:latin typeface="Arial"/>
                          <a:cs typeface="Arial"/>
                        </a:rPr>
                        <a:t>hpf</a:t>
                      </a:r>
                      <a:r>
                        <a:rPr lang="en-US" sz="800" b="0" i="0" baseline="0" dirty="0">
                          <a:latin typeface="Arial"/>
                          <a:cs typeface="Arial"/>
                        </a:rPr>
                        <a:t>. POD = Postoperative day.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27144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86002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0</Words>
  <Application>Microsoft Office PowerPoint</Application>
  <PresentationFormat>Widescreen</PresentationFormat>
  <Paragraphs>1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5:48Z</dcterms:created>
  <dcterms:modified xsi:type="dcterms:W3CDTF">2020-08-22T04:25:58Z</dcterms:modified>
</cp:coreProperties>
</file>